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308" r:id="rId2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FF7E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8014"/>
    <p:restoredTop sz="95712"/>
  </p:normalViewPr>
  <p:slideViewPr>
    <p:cSldViewPr snapToGrid="0">
      <p:cViewPr varScale="1">
        <p:scale>
          <a:sx n="55" d="100"/>
          <a:sy n="55" d="100"/>
        </p:scale>
        <p:origin x="2392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2C0627-6AA4-B048-BFF9-B30E068E963F}" type="datetimeFigureOut">
              <a:rPr lang="en-US" smtClean="0"/>
              <a:t>7/12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F41A1F-0BB6-1241-97AB-10F0BD8D24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9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99235-E7DC-2B4A-902E-F801E819B808}" type="datetimeFigureOut">
              <a:rPr lang="en-US" smtClean="0"/>
              <a:t>7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EA3-2119-144B-979C-2A11B0095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13378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99235-E7DC-2B4A-902E-F801E819B808}" type="datetimeFigureOut">
              <a:rPr lang="en-US" smtClean="0"/>
              <a:t>7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EA3-2119-144B-979C-2A11B0095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95428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99235-E7DC-2B4A-902E-F801E819B808}" type="datetimeFigureOut">
              <a:rPr lang="en-US" smtClean="0"/>
              <a:t>7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EA3-2119-144B-979C-2A11B0095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9564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99235-E7DC-2B4A-902E-F801E819B808}" type="datetimeFigureOut">
              <a:rPr lang="en-US" smtClean="0"/>
              <a:t>7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EA3-2119-144B-979C-2A11B0095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9484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99235-E7DC-2B4A-902E-F801E819B808}" type="datetimeFigureOut">
              <a:rPr lang="en-US" smtClean="0"/>
              <a:t>7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EA3-2119-144B-979C-2A11B0095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5644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99235-E7DC-2B4A-902E-F801E819B808}" type="datetimeFigureOut">
              <a:rPr lang="en-US" smtClean="0"/>
              <a:t>7/1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EA3-2119-144B-979C-2A11B0095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06657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99235-E7DC-2B4A-902E-F801E819B808}" type="datetimeFigureOut">
              <a:rPr lang="en-US" smtClean="0"/>
              <a:t>7/12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EA3-2119-144B-979C-2A11B0095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804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99235-E7DC-2B4A-902E-F801E819B808}" type="datetimeFigureOut">
              <a:rPr lang="en-US" smtClean="0"/>
              <a:t>7/12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EA3-2119-144B-979C-2A11B0095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5596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99235-E7DC-2B4A-902E-F801E819B808}" type="datetimeFigureOut">
              <a:rPr lang="en-US" smtClean="0"/>
              <a:t>7/12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EA3-2119-144B-979C-2A11B0095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843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99235-E7DC-2B4A-902E-F801E819B808}" type="datetimeFigureOut">
              <a:rPr lang="en-US" smtClean="0"/>
              <a:t>7/1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EA3-2119-144B-979C-2A11B0095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82824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C99235-E7DC-2B4A-902E-F801E819B808}" type="datetimeFigureOut">
              <a:rPr lang="en-US" smtClean="0"/>
              <a:t>7/12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67CEA3-2119-144B-979C-2A11B0095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478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C99235-E7DC-2B4A-902E-F801E819B808}" type="datetimeFigureOut">
              <a:rPr lang="en-US" smtClean="0"/>
              <a:t>7/12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67CEA3-2119-144B-979C-2A11B0095E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396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id="{9E272C37-45F9-977A-011A-5B07A03B9B7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1339" y="843843"/>
            <a:ext cx="3065300" cy="1969944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F809601E-3ED8-76BB-0CE8-A94C02EF1B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84641" y="3193301"/>
            <a:ext cx="3166849" cy="2108317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D37F1E97-D997-992D-7DCB-3D3C126BDD5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15965" y="821917"/>
            <a:ext cx="3065300" cy="2057416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6996E6FF-5719-3C07-7949-41BE98CFFA1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009267" y="3193301"/>
            <a:ext cx="3166850" cy="2108317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395D7E7E-071D-1E97-7A0B-742D46E16E75}"/>
              </a:ext>
            </a:extLst>
          </p:cNvPr>
          <p:cNvSpPr txBox="1"/>
          <p:nvPr/>
        </p:nvSpPr>
        <p:spPr>
          <a:xfrm>
            <a:off x="708193" y="677253"/>
            <a:ext cx="296876" cy="3250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68096">
              <a:spcAft>
                <a:spcPts val="600"/>
              </a:spcAft>
            </a:pPr>
            <a:r>
              <a:rPr lang="en-US" sz="1512" dirty="0"/>
              <a:t>A</a:t>
            </a:r>
            <a:endParaRPr 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8481EF1-8F50-814C-14CE-4F0D7EEDDFE7}"/>
              </a:ext>
            </a:extLst>
          </p:cNvPr>
          <p:cNvSpPr txBox="1"/>
          <p:nvPr/>
        </p:nvSpPr>
        <p:spPr>
          <a:xfrm>
            <a:off x="708193" y="2962411"/>
            <a:ext cx="290464" cy="3250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768096">
              <a:spcAft>
                <a:spcPts val="600"/>
              </a:spcAft>
            </a:pPr>
            <a:r>
              <a:rPr lang="en-US" sz="1512" dirty="0"/>
              <a:t>B</a:t>
            </a: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7907690-114C-F285-48F9-F36727251B45}"/>
              </a:ext>
            </a:extLst>
          </p:cNvPr>
          <p:cNvSpPr txBox="1"/>
          <p:nvPr/>
        </p:nvSpPr>
        <p:spPr>
          <a:xfrm>
            <a:off x="1005069" y="5601956"/>
            <a:ext cx="778152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dirty="0"/>
              <a:t>Figure S1. Distribution of the total proteins of the </a:t>
            </a:r>
            <a:r>
              <a:rPr lang="en-US" i="1" dirty="0"/>
              <a:t>M. </a:t>
            </a:r>
            <a:r>
              <a:rPr lang="en-US" i="1" dirty="0" err="1"/>
              <a:t>marinum</a:t>
            </a:r>
            <a:r>
              <a:rPr lang="en-US" dirty="0"/>
              <a:t> </a:t>
            </a:r>
            <a:r>
              <a:rPr lang="en-US" dirty="0" err="1"/>
              <a:t>secretome</a:t>
            </a:r>
            <a:r>
              <a:rPr lang="en-US" dirty="0"/>
              <a:t>. A) Isoelectric point (</a:t>
            </a:r>
            <a:r>
              <a:rPr lang="en-US" dirty="0" err="1"/>
              <a:t>pI</a:t>
            </a:r>
            <a:r>
              <a:rPr lang="en-US" dirty="0"/>
              <a:t>), and B) </a:t>
            </a:r>
            <a:r>
              <a:rPr lang="en-HK" dirty="0"/>
              <a:t>M</a:t>
            </a:r>
            <a:r>
              <a:rPr lang="en-HK" sz="1800" dirty="0">
                <a:effectLst/>
              </a:rPr>
              <a:t>olecular weight (MW) of the total proteins (left) and PE/PPE proteins (right) are plotted. Data were </a:t>
            </a:r>
            <a:r>
              <a:rPr lang="en-HK" dirty="0"/>
              <a:t>shown as the mean </a:t>
            </a:r>
            <a:r>
              <a:rPr lang="en-HK" b="0" i="0" dirty="0">
                <a:solidFill>
                  <a:srgbClr val="333333"/>
                </a:solidFill>
                <a:effectLst/>
              </a:rPr>
              <a:t>± SD with three individual experimental repeats. The </a:t>
            </a:r>
            <a:r>
              <a:rPr lang="en-HK" b="0" i="1" dirty="0">
                <a:solidFill>
                  <a:srgbClr val="333333"/>
                </a:solidFill>
                <a:effectLst/>
              </a:rPr>
              <a:t>p</a:t>
            </a:r>
            <a:r>
              <a:rPr lang="en-HK" b="0" i="0" dirty="0">
                <a:solidFill>
                  <a:srgbClr val="333333"/>
                </a:solidFill>
                <a:effectLst/>
              </a:rPr>
              <a:t>-value of data from Asp-N digest comparing with that of trypsin represent: *&lt;0.05, **&lt;0.01, ***&lt;0.005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096443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7749</TotalTime>
  <Words>87</Words>
  <Application>Microsoft Macintosh PowerPoint</Application>
  <PresentationFormat>A3 Paper (297x420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N, Lili</dc:creator>
  <cp:lastModifiedBy>YAN, Lili</cp:lastModifiedBy>
  <cp:revision>15</cp:revision>
  <cp:lastPrinted>2023-05-11T10:45:52Z</cp:lastPrinted>
  <dcterms:created xsi:type="dcterms:W3CDTF">2022-10-14T04:32:07Z</dcterms:created>
  <dcterms:modified xsi:type="dcterms:W3CDTF">2024-07-12T07:54:42Z</dcterms:modified>
</cp:coreProperties>
</file>